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9929813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schula, CH, Dr &lt;kaschula@sun.ac.za&gt;" initials="KCD&lt;" lastIdx="3" clrIdx="0">
    <p:extLst/>
  </p:cmAuthor>
  <p:cmAuthor id="2" name="Georgia Schafer" initials="GS" lastIdx="1" clrIdx="1">
    <p:extLst/>
  </p:cmAuthor>
  <p:cmAuthor id="3" name="Chris Barnett" initials="CB" lastIdx="3" clrIdx="2">
    <p:extLst>
      <p:ext uri="{19B8F6BF-5375-455C-9EA6-DF929625EA0E}">
        <p15:presenceInfo xmlns:p15="http://schemas.microsoft.com/office/powerpoint/2012/main" userId="S-1-5-21-3848398101-821531346-3615173760-1001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501" autoAdjust="0"/>
    <p:restoredTop sz="94366" autoAdjust="0"/>
  </p:normalViewPr>
  <p:slideViewPr>
    <p:cSldViewPr>
      <p:cViewPr varScale="1">
        <p:scale>
          <a:sx n="65" d="100"/>
          <a:sy n="65" d="100"/>
        </p:scale>
        <p:origin x="980" y="4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2919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4597" y="0"/>
            <a:ext cx="4302919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9EDF8B-D80C-40C0-9EA1-60E30FC7C958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435350" y="849313"/>
            <a:ext cx="3059113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982" y="3271381"/>
            <a:ext cx="794385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6612"/>
            <a:ext cx="4302919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4597" y="6456612"/>
            <a:ext cx="4302919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1618F-7F06-49A1-A3D1-BB24EAAEDC2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353051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12389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5941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83669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911852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1315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72233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42241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64133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27875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21367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71831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393F7-8178-464A-B57F-49A2BE957A4A}" type="datetimeFigureOut">
              <a:rPr lang="en-ZA" smtClean="0"/>
              <a:t>2019/01/3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1BB95F-3996-400A-8334-306D5D41812E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70025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1F673E3-45D3-4D1D-B677-6CDF72225DC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7784" y="3284984"/>
            <a:ext cx="4212470" cy="280831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95936" y="116632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Z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5149647"/>
              </p:ext>
            </p:extLst>
          </p:nvPr>
        </p:nvGraphicFramePr>
        <p:xfrm>
          <a:off x="2330749" y="1214826"/>
          <a:ext cx="4617515" cy="19202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295256">
                  <a:extLst>
                    <a:ext uri="{9D8B030D-6E8A-4147-A177-3AD203B41FA5}">
                      <a16:colId xmlns:a16="http://schemas.microsoft.com/office/drawing/2014/main" val="1194559677"/>
                    </a:ext>
                  </a:extLst>
                </a:gridCol>
                <a:gridCol w="918102">
                  <a:extLst>
                    <a:ext uri="{9D8B030D-6E8A-4147-A177-3AD203B41FA5}">
                      <a16:colId xmlns:a16="http://schemas.microsoft.com/office/drawing/2014/main" val="524534028"/>
                    </a:ext>
                  </a:extLst>
                </a:gridCol>
                <a:gridCol w="702078">
                  <a:extLst>
                    <a:ext uri="{9D8B030D-6E8A-4147-A177-3AD203B41FA5}">
                      <a16:colId xmlns:a16="http://schemas.microsoft.com/office/drawing/2014/main" val="152078616"/>
                    </a:ext>
                  </a:extLst>
                </a:gridCol>
                <a:gridCol w="702079">
                  <a:extLst>
                    <a:ext uri="{9D8B030D-6E8A-4147-A177-3AD203B41FA5}">
                      <a16:colId xmlns:a16="http://schemas.microsoft.com/office/drawing/2014/main" val="4096737263"/>
                    </a:ext>
                  </a:extLst>
                </a:gridCol>
              </a:tblGrid>
              <a:tr h="41148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l system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pirical </a:t>
                      </a:r>
                      <a:r>
                        <a:rPr lang="en-ZA" sz="7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K</a:t>
                      </a:r>
                      <a:r>
                        <a:rPr lang="en-ZA" sz="700" baseline="-250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C-C-S torsion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C-S-H torsion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3488071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S (zwitterion)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52 ± 0.86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1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78.0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6808062"/>
                  </a:ext>
                </a:extLst>
              </a:tr>
              <a:tr h="41148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in A &amp; B (from RQVQSLTCEVDALK). Both chains included in calculation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7 ± </a:t>
                      </a:r>
                      <a:r>
                        <a:rPr lang="en-ZA" sz="7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2 (for A)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ZA" sz="7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7 ± 2.22 (for B)</a:t>
                      </a: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8 (for A)</a:t>
                      </a: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ZA" sz="7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9.3 (for B)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0.0 (for A)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4 (for B)</a:t>
                      </a: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9579060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in A TCE</a:t>
                      </a:r>
                      <a:endParaRPr lang="en-ZA" sz="7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9 ± 1.12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8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0.0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6427633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in B TCE</a:t>
                      </a:r>
                      <a:endParaRPr lang="en-ZA" sz="7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9 ± 1.12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9.3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4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9312734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in C TCE</a:t>
                      </a:r>
                      <a:endParaRPr lang="en-ZA" sz="7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9 ± 1.12</a:t>
                      </a:r>
                      <a:endParaRPr lang="en-ZA" sz="7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7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0.0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3043884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in D TCE</a:t>
                      </a:r>
                      <a:endParaRPr lang="en-ZA" sz="7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9 ± 1.12</a:t>
                      </a:r>
                      <a:endParaRPr lang="en-ZA" sz="7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3</a:t>
                      </a:r>
                      <a:endParaRPr lang="en-ZA" sz="7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ZA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0.0</a:t>
                      </a:r>
                      <a:endParaRPr lang="en-ZA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2645652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2195736" y="764704"/>
            <a:ext cx="4752528" cy="4385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pPr algn="ctr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ZA" altLang="en-US" sz="750" b="1" dirty="0">
                <a:solidFill>
                  <a:srgbClr val="131413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1</a:t>
            </a:r>
            <a:r>
              <a:rPr lang="en-ZA" altLang="en-US" sz="750" dirty="0">
                <a:solidFill>
                  <a:srgbClr val="131413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A summary of </a:t>
            </a:r>
            <a:r>
              <a:rPr lang="en-ZA" altLang="en-US" sz="750" dirty="0" err="1">
                <a:solidFill>
                  <a:srgbClr val="131413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ZA" altLang="en-US" sz="750" i="1" dirty="0" err="1">
                <a:solidFill>
                  <a:srgbClr val="131413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</a:t>
            </a:r>
            <a:r>
              <a:rPr lang="en-ZA" altLang="en-US" sz="750" baseline="-30000" dirty="0" err="1">
                <a:solidFill>
                  <a:srgbClr val="131413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ZA" altLang="en-US" sz="750" dirty="0">
                <a:solidFill>
                  <a:srgbClr val="131413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edictions and torsional angles for model systems of cysteine and cysteine in </a:t>
            </a:r>
            <a:r>
              <a:rPr lang="en-ZA" altLang="en-US" sz="750" dirty="0" err="1">
                <a:solidFill>
                  <a:srgbClr val="131413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mentin</a:t>
            </a:r>
            <a:endParaRPr lang="en-ZA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ZA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1329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6</TotalTime>
  <Words>118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herine</dc:creator>
  <cp:lastModifiedBy>Kaschula, CH, Dr &lt;kaschula@sun.ac.za&gt;</cp:lastModifiedBy>
  <cp:revision>102</cp:revision>
  <cp:lastPrinted>2017-12-11T11:23:10Z</cp:lastPrinted>
  <dcterms:created xsi:type="dcterms:W3CDTF">2015-06-09T13:18:46Z</dcterms:created>
  <dcterms:modified xsi:type="dcterms:W3CDTF">2019-01-31T11:20:26Z</dcterms:modified>
</cp:coreProperties>
</file>